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5"/>
  </p:notesMasterIdLst>
  <p:sldIdLst>
    <p:sldId id="266" r:id="rId2"/>
    <p:sldId id="268" r:id="rId3"/>
    <p:sldId id="269" r:id="rId4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6993" autoAdjust="0"/>
    <p:restoredTop sz="94687" autoAdjust="0"/>
  </p:normalViewPr>
  <p:slideViewPr>
    <p:cSldViewPr snapToGrid="0">
      <p:cViewPr varScale="1">
        <p:scale>
          <a:sx n="133" d="100"/>
          <a:sy n="133" d="100"/>
        </p:scale>
        <p:origin x="110" y="965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57A01B1-03D9-41B2-839A-108DF4E887AC}" type="datetimeFigureOut">
              <a:rPr lang="en-CA" smtClean="0"/>
              <a:t>2022-11-30</a:t>
            </a:fld>
            <a:endParaRPr lang="en-CA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CA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8FD85F1-ADFD-4A2C-91E7-8B6F412104C2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15928180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Online supplemental figure 1. Unadjusted relationships of docosahexaenoic acid percentage (DHA%) with (A) red blood cell distribution width (RDW) and (B) neutrophil-lymphocyte ratio (NLR) in 109,101 individuals in the UK Biobank cohort. Predicted means and 95% confidence bands excluding values &lt;5</a:t>
            </a:r>
            <a:r>
              <a:rPr lang="en-US" baseline="30000" dirty="0"/>
              <a:t>th</a:t>
            </a:r>
            <a:r>
              <a:rPr lang="en-US" dirty="0"/>
              <a:t> and &gt;95</a:t>
            </a:r>
            <a:r>
              <a:rPr lang="en-US" baseline="30000" dirty="0"/>
              <a:t>th</a:t>
            </a:r>
            <a:r>
              <a:rPr lang="en-US" dirty="0"/>
              <a:t> percentile for DHA%. </a:t>
            </a:r>
            <a:endParaRPr lang="en-CA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8FD85F1-ADFD-4A2C-91E7-8B6F412104C2}" type="slidenum">
              <a:rPr lang="en-CA" smtClean="0"/>
              <a:t>1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83482052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Online supplemental figure 2. Adjusted relationships between the omega-3 percentage (Omega3%) with (A) red blood cell distribution width (RDW) and (B) neutrophil-lymphocyte ratio (NLR) in 109,101 individuals in the UK Biobank cohort. Predicted means and 95% confidence bands excluding values &lt;5</a:t>
            </a:r>
            <a:r>
              <a:rPr lang="en-US" baseline="30000" dirty="0"/>
              <a:t>th</a:t>
            </a:r>
            <a:r>
              <a:rPr lang="en-US" dirty="0"/>
              <a:t> and &gt;95</a:t>
            </a:r>
            <a:r>
              <a:rPr lang="en-US" baseline="30000" dirty="0"/>
              <a:t>th</a:t>
            </a:r>
            <a:r>
              <a:rPr lang="en-US" dirty="0"/>
              <a:t> percentile for DHA%. </a:t>
            </a:r>
            <a:endParaRPr lang="en-CA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8FD85F1-ADFD-4A2C-91E7-8B6F412104C2}" type="slidenum">
              <a:rPr lang="en-CA" smtClean="0"/>
              <a:t>2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22360893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Online supplemental figure 1. Adjusted relationships between the docosahexaenoic acid percentage (DHA%) with (A) red blood cell distribution width (RDW) and (B) neutrophil-lymphocyte ratio (NLR) in 109,101 individuals in the UK Biobank cohort. Predicted means and 95% confidence bands excluding values &lt;5</a:t>
            </a:r>
            <a:r>
              <a:rPr lang="en-US" baseline="30000" dirty="0"/>
              <a:t>th</a:t>
            </a:r>
            <a:r>
              <a:rPr lang="en-US" dirty="0"/>
              <a:t> and &gt;95</a:t>
            </a:r>
            <a:r>
              <a:rPr lang="en-US" baseline="30000" dirty="0"/>
              <a:t>th</a:t>
            </a:r>
            <a:r>
              <a:rPr lang="en-US" dirty="0"/>
              <a:t> percentile for DHA%. </a:t>
            </a:r>
            <a:endParaRPr lang="en-CA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8FD85F1-ADFD-4A2C-91E7-8B6F412104C2}" type="slidenum">
              <a:rPr lang="en-CA" smtClean="0"/>
              <a:t>3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13905709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9EB91D-87C3-4865-ABFC-6009C693823D}" type="datetimeFigureOut">
              <a:rPr lang="en-CA" smtClean="0"/>
              <a:t>2022-11-30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AA36B5-B3FB-4658-8216-2A785867848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8158485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9EB91D-87C3-4865-ABFC-6009C693823D}" type="datetimeFigureOut">
              <a:rPr lang="en-CA" smtClean="0"/>
              <a:t>2022-11-30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AA36B5-B3FB-4658-8216-2A785867848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6310444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9EB91D-87C3-4865-ABFC-6009C693823D}" type="datetimeFigureOut">
              <a:rPr lang="en-CA" smtClean="0"/>
              <a:t>2022-11-30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AA36B5-B3FB-4658-8216-2A785867848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9485340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9EB91D-87C3-4865-ABFC-6009C693823D}" type="datetimeFigureOut">
              <a:rPr lang="en-CA" smtClean="0"/>
              <a:t>2022-11-30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AA36B5-B3FB-4658-8216-2A785867848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7484853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9EB91D-87C3-4865-ABFC-6009C693823D}" type="datetimeFigureOut">
              <a:rPr lang="en-CA" smtClean="0"/>
              <a:t>2022-11-30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AA36B5-B3FB-4658-8216-2A785867848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7179639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9EB91D-87C3-4865-ABFC-6009C693823D}" type="datetimeFigureOut">
              <a:rPr lang="en-CA" smtClean="0"/>
              <a:t>2022-11-30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AA36B5-B3FB-4658-8216-2A785867848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9703065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9EB91D-87C3-4865-ABFC-6009C693823D}" type="datetimeFigureOut">
              <a:rPr lang="en-CA" smtClean="0"/>
              <a:t>2022-11-30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AA36B5-B3FB-4658-8216-2A785867848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4329335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9EB91D-87C3-4865-ABFC-6009C693823D}" type="datetimeFigureOut">
              <a:rPr lang="en-CA" smtClean="0"/>
              <a:t>2022-11-30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AA36B5-B3FB-4658-8216-2A785867848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2542316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9EB91D-87C3-4865-ABFC-6009C693823D}" type="datetimeFigureOut">
              <a:rPr lang="en-CA" smtClean="0"/>
              <a:t>2022-11-30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AA36B5-B3FB-4658-8216-2A785867848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8199114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9EB91D-87C3-4865-ABFC-6009C693823D}" type="datetimeFigureOut">
              <a:rPr lang="en-CA" smtClean="0"/>
              <a:t>2022-11-30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AA36B5-B3FB-4658-8216-2A785867848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9705227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9EB91D-87C3-4865-ABFC-6009C693823D}" type="datetimeFigureOut">
              <a:rPr lang="en-CA" smtClean="0"/>
              <a:t>2022-11-30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AA36B5-B3FB-4658-8216-2A785867848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45972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89EB91D-87C3-4865-ABFC-6009C693823D}" type="datetimeFigureOut">
              <a:rPr lang="en-CA" smtClean="0"/>
              <a:t>2022-11-30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AA36B5-B3FB-4658-8216-2A7858678480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7270998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4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" name="Picture 15">
            <a:extLst>
              <a:ext uri="{FF2B5EF4-FFF2-40B4-BE49-F238E27FC236}">
                <a16:creationId xmlns:a16="http://schemas.microsoft.com/office/drawing/2014/main" id="{BC211C9D-E43E-8BF5-D43B-FC3A659E6E4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895060" y="113741"/>
            <a:ext cx="4269990" cy="3434495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10A2B553-79F2-74A5-08F5-FB84D04E42F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067638" y="3590024"/>
            <a:ext cx="4097412" cy="3267976"/>
          </a:xfrm>
          <a:prstGeom prst="rect">
            <a:avLst/>
          </a:prstGeom>
        </p:spPr>
      </p:pic>
      <p:sp>
        <p:nvSpPr>
          <p:cNvPr id="44" name="TextBox 43">
            <a:extLst>
              <a:ext uri="{FF2B5EF4-FFF2-40B4-BE49-F238E27FC236}">
                <a16:creationId xmlns:a16="http://schemas.microsoft.com/office/drawing/2014/main" id="{32F91D52-09FF-9FF2-B5E6-9D29295CF53E}"/>
              </a:ext>
            </a:extLst>
          </p:cNvPr>
          <p:cNvSpPr txBox="1"/>
          <p:nvPr/>
        </p:nvSpPr>
        <p:spPr>
          <a:xfrm>
            <a:off x="2686505" y="2847474"/>
            <a:ext cx="7729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200" dirty="0"/>
              <a:t>p&lt;0.0001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89C0061A-E3ED-04B2-69B6-E69FA927CD46}"/>
              </a:ext>
            </a:extLst>
          </p:cNvPr>
          <p:cNvSpPr txBox="1"/>
          <p:nvPr/>
        </p:nvSpPr>
        <p:spPr>
          <a:xfrm>
            <a:off x="5450127" y="563905"/>
            <a:ext cx="230606" cy="2756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dirty="0"/>
              <a:t>A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D9FF2366-2487-54F0-E63F-E6BC811D3C4B}"/>
              </a:ext>
            </a:extLst>
          </p:cNvPr>
          <p:cNvSpPr txBox="1"/>
          <p:nvPr/>
        </p:nvSpPr>
        <p:spPr>
          <a:xfrm>
            <a:off x="5450127" y="3739405"/>
            <a:ext cx="2680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200" dirty="0"/>
              <a:t>B</a:t>
            </a:r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161063C4-42C4-3F2B-5B15-89B124C7A5C0}"/>
              </a:ext>
            </a:extLst>
          </p:cNvPr>
          <p:cNvSpPr/>
          <p:nvPr/>
        </p:nvSpPr>
        <p:spPr>
          <a:xfrm>
            <a:off x="3753365" y="6671236"/>
            <a:ext cx="985158" cy="18676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sz="1100" dirty="0">
                <a:solidFill>
                  <a:schemeClr val="tx1"/>
                </a:solidFill>
              </a:rPr>
              <a:t>DHA%</a:t>
            </a:r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42DCF010-286D-BFEC-6F2D-20C113B09504}"/>
              </a:ext>
            </a:extLst>
          </p:cNvPr>
          <p:cNvSpPr/>
          <p:nvPr/>
        </p:nvSpPr>
        <p:spPr>
          <a:xfrm>
            <a:off x="3623765" y="3361472"/>
            <a:ext cx="985158" cy="18676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sz="1100" dirty="0">
                <a:solidFill>
                  <a:schemeClr val="tx1"/>
                </a:solidFill>
              </a:rPr>
              <a:t>DHA%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26BCA913-6780-D3B6-6E84-A28D31A9D98B}"/>
              </a:ext>
            </a:extLst>
          </p:cNvPr>
          <p:cNvSpPr txBox="1"/>
          <p:nvPr/>
        </p:nvSpPr>
        <p:spPr>
          <a:xfrm>
            <a:off x="2686504" y="6125404"/>
            <a:ext cx="7729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200" dirty="0"/>
              <a:t>p&lt;0.0001</a:t>
            </a:r>
          </a:p>
        </p:txBody>
      </p:sp>
    </p:spTree>
    <p:extLst>
      <p:ext uri="{BB962C8B-B14F-4D97-AF65-F5344CB8AC3E}">
        <p14:creationId xmlns:p14="http://schemas.microsoft.com/office/powerpoint/2010/main" val="20061199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5" name="Picture 34">
            <a:extLst>
              <a:ext uri="{FF2B5EF4-FFF2-40B4-BE49-F238E27FC236}">
                <a16:creationId xmlns:a16="http://schemas.microsoft.com/office/drawing/2014/main" id="{B3661C9D-869E-9F52-6041-3E93DBEA52B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63946" y="3504703"/>
            <a:ext cx="4166228" cy="3327936"/>
          </a:xfrm>
          <a:prstGeom prst="rect">
            <a:avLst/>
          </a:prstGeom>
        </p:spPr>
      </p:pic>
      <p:pic>
        <p:nvPicPr>
          <p:cNvPr id="31" name="Picture 30">
            <a:extLst>
              <a:ext uri="{FF2B5EF4-FFF2-40B4-BE49-F238E27FC236}">
                <a16:creationId xmlns:a16="http://schemas.microsoft.com/office/drawing/2014/main" id="{7020B71F-4628-7CAB-8D72-9B4035B086A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385375" y="148844"/>
            <a:ext cx="4221795" cy="3355859"/>
          </a:xfrm>
          <a:prstGeom prst="rect">
            <a:avLst/>
          </a:prstGeom>
        </p:spPr>
      </p:pic>
      <p:sp>
        <p:nvSpPr>
          <p:cNvPr id="23" name="TextBox 22">
            <a:extLst>
              <a:ext uri="{FF2B5EF4-FFF2-40B4-BE49-F238E27FC236}">
                <a16:creationId xmlns:a16="http://schemas.microsoft.com/office/drawing/2014/main" id="{4F86EFB7-707E-98EE-47B2-BEDE100435C5}"/>
              </a:ext>
            </a:extLst>
          </p:cNvPr>
          <p:cNvSpPr txBox="1"/>
          <p:nvPr/>
        </p:nvSpPr>
        <p:spPr>
          <a:xfrm>
            <a:off x="5166773" y="293684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dirty="0"/>
              <a:t>A</a:t>
            </a:r>
          </a:p>
        </p:txBody>
      </p:sp>
      <p:sp>
        <p:nvSpPr>
          <p:cNvPr id="28" name="Rectangle 27">
            <a:extLst>
              <a:ext uri="{FF2B5EF4-FFF2-40B4-BE49-F238E27FC236}">
                <a16:creationId xmlns:a16="http://schemas.microsoft.com/office/drawing/2014/main" id="{77BE8D57-7AFC-BA30-53C2-29E9A89DB6FF}"/>
              </a:ext>
            </a:extLst>
          </p:cNvPr>
          <p:cNvSpPr/>
          <p:nvPr/>
        </p:nvSpPr>
        <p:spPr>
          <a:xfrm>
            <a:off x="3304113" y="6666971"/>
            <a:ext cx="985158" cy="18676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sz="1100" dirty="0">
                <a:solidFill>
                  <a:schemeClr val="tx1"/>
                </a:solidFill>
              </a:rPr>
              <a:t>Omega3%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91ABF439-07B7-30FA-66F0-2473AA9BDC2E}"/>
              </a:ext>
            </a:extLst>
          </p:cNvPr>
          <p:cNvSpPr txBox="1"/>
          <p:nvPr/>
        </p:nvSpPr>
        <p:spPr>
          <a:xfrm>
            <a:off x="2082848" y="6034615"/>
            <a:ext cx="7729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200" dirty="0"/>
              <a:t>p&lt;0.0001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98F2C144-6A3E-3C93-A37B-0DA0F1816A4E}"/>
              </a:ext>
            </a:extLst>
          </p:cNvPr>
          <p:cNvSpPr txBox="1"/>
          <p:nvPr/>
        </p:nvSpPr>
        <p:spPr>
          <a:xfrm>
            <a:off x="5088061" y="3598506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dirty="0"/>
              <a:t>B</a:t>
            </a:r>
          </a:p>
        </p:txBody>
      </p:sp>
      <p:sp>
        <p:nvSpPr>
          <p:cNvPr id="34" name="Rectangle 33">
            <a:extLst>
              <a:ext uri="{FF2B5EF4-FFF2-40B4-BE49-F238E27FC236}">
                <a16:creationId xmlns:a16="http://schemas.microsoft.com/office/drawing/2014/main" id="{F3C6E118-BDB8-3275-5003-65D7F39995C7}"/>
              </a:ext>
            </a:extLst>
          </p:cNvPr>
          <p:cNvSpPr/>
          <p:nvPr/>
        </p:nvSpPr>
        <p:spPr>
          <a:xfrm>
            <a:off x="3211608" y="3317939"/>
            <a:ext cx="985158" cy="18676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sz="1100" dirty="0">
                <a:solidFill>
                  <a:schemeClr val="tx1"/>
                </a:solidFill>
              </a:rPr>
              <a:t>Omega3%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65579685-76F1-B445-C611-ECBB2730E575}"/>
              </a:ext>
            </a:extLst>
          </p:cNvPr>
          <p:cNvSpPr txBox="1"/>
          <p:nvPr/>
        </p:nvSpPr>
        <p:spPr>
          <a:xfrm>
            <a:off x="2094280" y="2623132"/>
            <a:ext cx="7729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200" dirty="0"/>
              <a:t>P&lt;0.0001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8D24E289-6A21-40F5-2A6B-912719FCE7F0}"/>
              </a:ext>
            </a:extLst>
          </p:cNvPr>
          <p:cNvSpPr txBox="1"/>
          <p:nvPr/>
        </p:nvSpPr>
        <p:spPr>
          <a:xfrm>
            <a:off x="3123522" y="1129088"/>
            <a:ext cx="236096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Adjusted for sex, age, BMI and CRP</a:t>
            </a:r>
            <a:endParaRPr lang="en-CA" sz="1200" dirty="0"/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DDBA455F-A8D8-69D3-2091-6B27B27CB720}"/>
              </a:ext>
            </a:extLst>
          </p:cNvPr>
          <p:cNvSpPr txBox="1"/>
          <p:nvPr/>
        </p:nvSpPr>
        <p:spPr>
          <a:xfrm>
            <a:off x="2998487" y="4109274"/>
            <a:ext cx="26110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Adjusted for sex, age, BMI, CRP and Hb</a:t>
            </a:r>
            <a:endParaRPr lang="en-CA" sz="1200" dirty="0"/>
          </a:p>
        </p:txBody>
      </p:sp>
    </p:spTree>
    <p:extLst>
      <p:ext uri="{BB962C8B-B14F-4D97-AF65-F5344CB8AC3E}">
        <p14:creationId xmlns:p14="http://schemas.microsoft.com/office/powerpoint/2010/main" val="58632949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7" name="Picture 26">
            <a:extLst>
              <a:ext uri="{FF2B5EF4-FFF2-40B4-BE49-F238E27FC236}">
                <a16:creationId xmlns:a16="http://schemas.microsoft.com/office/drawing/2014/main" id="{18EA8C0A-A3A6-EA02-FF33-BA82F76AA83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75152" y="3504703"/>
            <a:ext cx="4233789" cy="3349032"/>
          </a:xfrm>
          <a:prstGeom prst="rect">
            <a:avLst/>
          </a:prstGeom>
        </p:spPr>
      </p:pic>
      <p:pic>
        <p:nvPicPr>
          <p:cNvPr id="25" name="Picture 24">
            <a:extLst>
              <a:ext uri="{FF2B5EF4-FFF2-40B4-BE49-F238E27FC236}">
                <a16:creationId xmlns:a16="http://schemas.microsoft.com/office/drawing/2014/main" id="{37757CE5-B563-61A8-7106-44CA63D6951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367562" y="121710"/>
            <a:ext cx="4233788" cy="3382993"/>
          </a:xfrm>
          <a:prstGeom prst="rect">
            <a:avLst/>
          </a:prstGeom>
        </p:spPr>
      </p:pic>
      <p:sp>
        <p:nvSpPr>
          <p:cNvPr id="23" name="TextBox 22">
            <a:extLst>
              <a:ext uri="{FF2B5EF4-FFF2-40B4-BE49-F238E27FC236}">
                <a16:creationId xmlns:a16="http://schemas.microsoft.com/office/drawing/2014/main" id="{4F86EFB7-707E-98EE-47B2-BEDE100435C5}"/>
              </a:ext>
            </a:extLst>
          </p:cNvPr>
          <p:cNvSpPr txBox="1"/>
          <p:nvPr/>
        </p:nvSpPr>
        <p:spPr>
          <a:xfrm>
            <a:off x="5166773" y="293684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dirty="0"/>
              <a:t>A</a:t>
            </a:r>
          </a:p>
        </p:txBody>
      </p:sp>
      <p:sp>
        <p:nvSpPr>
          <p:cNvPr id="28" name="Rectangle 27">
            <a:extLst>
              <a:ext uri="{FF2B5EF4-FFF2-40B4-BE49-F238E27FC236}">
                <a16:creationId xmlns:a16="http://schemas.microsoft.com/office/drawing/2014/main" id="{77BE8D57-7AFC-BA30-53C2-29E9A89DB6FF}"/>
              </a:ext>
            </a:extLst>
          </p:cNvPr>
          <p:cNvSpPr/>
          <p:nvPr/>
        </p:nvSpPr>
        <p:spPr>
          <a:xfrm>
            <a:off x="3304113" y="6666971"/>
            <a:ext cx="985158" cy="18676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sz="1100" dirty="0">
                <a:solidFill>
                  <a:schemeClr val="tx1"/>
                </a:solidFill>
              </a:rPr>
              <a:t>DHA%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91ABF439-07B7-30FA-66F0-2473AA9BDC2E}"/>
              </a:ext>
            </a:extLst>
          </p:cNvPr>
          <p:cNvSpPr txBox="1"/>
          <p:nvPr/>
        </p:nvSpPr>
        <p:spPr>
          <a:xfrm>
            <a:off x="2082848" y="6034615"/>
            <a:ext cx="7729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200" dirty="0"/>
              <a:t>p&lt;0.0001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98F2C144-6A3E-3C93-A37B-0DA0F1816A4E}"/>
              </a:ext>
            </a:extLst>
          </p:cNvPr>
          <p:cNvSpPr txBox="1"/>
          <p:nvPr/>
        </p:nvSpPr>
        <p:spPr>
          <a:xfrm>
            <a:off x="5088061" y="3598506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dirty="0"/>
              <a:t>B</a:t>
            </a:r>
          </a:p>
        </p:txBody>
      </p:sp>
      <p:sp>
        <p:nvSpPr>
          <p:cNvPr id="34" name="Rectangle 33">
            <a:extLst>
              <a:ext uri="{FF2B5EF4-FFF2-40B4-BE49-F238E27FC236}">
                <a16:creationId xmlns:a16="http://schemas.microsoft.com/office/drawing/2014/main" id="{F3C6E118-BDB8-3275-5003-65D7F39995C7}"/>
              </a:ext>
            </a:extLst>
          </p:cNvPr>
          <p:cNvSpPr/>
          <p:nvPr/>
        </p:nvSpPr>
        <p:spPr>
          <a:xfrm>
            <a:off x="3211608" y="3317939"/>
            <a:ext cx="985158" cy="18676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sz="1100" dirty="0">
                <a:solidFill>
                  <a:schemeClr val="tx1"/>
                </a:solidFill>
              </a:rPr>
              <a:t>DHA%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65579685-76F1-B445-C611-ECBB2730E575}"/>
              </a:ext>
            </a:extLst>
          </p:cNvPr>
          <p:cNvSpPr txBox="1"/>
          <p:nvPr/>
        </p:nvSpPr>
        <p:spPr>
          <a:xfrm>
            <a:off x="2094280" y="2623132"/>
            <a:ext cx="85151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200" dirty="0"/>
              <a:t>p=0.00033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CF5C22E-F4E3-03EB-CB46-BBFC804D370F}"/>
              </a:ext>
            </a:extLst>
          </p:cNvPr>
          <p:cNvSpPr txBox="1"/>
          <p:nvPr/>
        </p:nvSpPr>
        <p:spPr>
          <a:xfrm>
            <a:off x="3240383" y="834990"/>
            <a:ext cx="236096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Adjusted for sex, age, BMI and CRP</a:t>
            </a:r>
            <a:endParaRPr lang="en-CA" sz="1200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F18FACCF-C1F8-FB24-1410-9AB89AEC6C1D}"/>
              </a:ext>
            </a:extLst>
          </p:cNvPr>
          <p:cNvSpPr txBox="1"/>
          <p:nvPr/>
        </p:nvSpPr>
        <p:spPr>
          <a:xfrm>
            <a:off x="3016282" y="3907509"/>
            <a:ext cx="26110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Adjusted for sex, age, BMI, CRP and Hb</a:t>
            </a:r>
            <a:endParaRPr lang="en-CA" sz="1200" dirty="0"/>
          </a:p>
        </p:txBody>
      </p:sp>
    </p:spTree>
    <p:extLst>
      <p:ext uri="{BB962C8B-B14F-4D97-AF65-F5344CB8AC3E}">
        <p14:creationId xmlns:p14="http://schemas.microsoft.com/office/powerpoint/2010/main" val="5009697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96</TotalTime>
  <Words>266</Words>
  <Application>Microsoft Office PowerPoint</Application>
  <PresentationFormat>On-screen Show (4:3)</PresentationFormat>
  <Paragraphs>28</Paragraphs>
  <Slides>3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hael McBurney</dc:creator>
  <cp:lastModifiedBy>Michael McBurney</cp:lastModifiedBy>
  <cp:revision>21</cp:revision>
  <dcterms:created xsi:type="dcterms:W3CDTF">2022-06-24T18:43:51Z</dcterms:created>
  <dcterms:modified xsi:type="dcterms:W3CDTF">2022-11-30T22:07:14Z</dcterms:modified>
</cp:coreProperties>
</file>